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992" y="-8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804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328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242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491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411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731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59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892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94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275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785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D3BFF-677B-4777-9A7F-D4AAFBE60C84}" type="datetimeFigureOut">
              <a:rPr lang="en-US" smtClean="0"/>
              <a:t>10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63BB3F-2F9C-490A-87B3-41E82FBC55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424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5800" y="228600"/>
            <a:ext cx="7848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Supplementary Figure 1</a:t>
            </a:r>
            <a:r>
              <a:rPr lang="en-US" sz="1200" b="1" dirty="0" smtClean="0"/>
              <a:t>. </a:t>
            </a:r>
            <a:r>
              <a:rPr lang="en-US" sz="1200" dirty="0" smtClean="0"/>
              <a:t>Ingenuity interaction networks for the miRNAs reorganized in aggressive high-risk metastatic neuroblastoma. All networks identified by IPA converge at biological functions that endorses </a:t>
            </a:r>
            <a:r>
              <a:rPr lang="en-US" sz="1200" dirty="0" err="1" smtClean="0"/>
              <a:t>metastatsis</a:t>
            </a:r>
            <a:r>
              <a:rPr lang="en-US" sz="1200" dirty="0" smtClean="0"/>
              <a:t> and, thereby signify their role as metastamiRs</a:t>
            </a:r>
            <a:endParaRPr lang="en-US" sz="1200" b="1" dirty="0"/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61"/>
          <a:stretch/>
        </p:blipFill>
        <p:spPr bwMode="auto">
          <a:xfrm>
            <a:off x="762000" y="1088932"/>
            <a:ext cx="7772400" cy="5388068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52323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1</TotalTime>
  <Words>3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UH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vindan, Natarajan  (HSC)</dc:creator>
  <cp:lastModifiedBy>Aravindan, Natarajan  (HSC)</cp:lastModifiedBy>
  <cp:revision>5</cp:revision>
  <cp:lastPrinted>2014-10-02T21:35:30Z</cp:lastPrinted>
  <dcterms:created xsi:type="dcterms:W3CDTF">2014-09-29T16:14:19Z</dcterms:created>
  <dcterms:modified xsi:type="dcterms:W3CDTF">2014-10-03T19:24:01Z</dcterms:modified>
</cp:coreProperties>
</file>